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0080625" cy="5670550"/>
  <p:notesSz cx="7559675" cy="10691813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0" d="100"/>
          <a:sy n="120" d="100"/>
        </p:scale>
        <p:origin x="9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>
            <a:extLst>
              <a:ext uri="{FF2B5EF4-FFF2-40B4-BE49-F238E27FC236}">
                <a16:creationId xmlns:a16="http://schemas.microsoft.com/office/drawing/2014/main" id="{2F0CB854-2079-49FE-9160-94704D966504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pt-BR" sz="1400" b="0" i="0" u="none" strike="noStrike" kern="1200" cap="none">
              <a:ln>
                <a:noFill/>
              </a:ln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5D778C52-0576-48D3-884D-8B1B43668227}"/>
              </a:ext>
            </a:extLst>
          </p:cNvPr>
          <p:cNvSpPr txBox="1">
            <a:spLocks noGrp="1"/>
          </p:cNvSpPr>
          <p:nvPr>
            <p:ph type="dt" sz="quarter" idx="1"/>
          </p:nvPr>
        </p:nvSpPr>
        <p:spPr>
          <a:xfrm>
            <a:off x="427896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pt-BR" sz="1400" b="0" i="0" u="none" strike="noStrike" kern="1200" cap="none">
              <a:ln>
                <a:noFill/>
              </a:ln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91112D1C-2A12-4882-952F-EDF231D1D282}"/>
              </a:ext>
            </a:extLst>
          </p:cNvPr>
          <p:cNvSpPr txBox="1">
            <a:spLocks noGrp="1"/>
          </p:cNvSpPr>
          <p:nvPr>
            <p:ph type="ftr" sz="quarter" idx="2"/>
          </p:nvPr>
        </p:nvSpPr>
        <p:spPr>
          <a:xfrm>
            <a:off x="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pt-BR" sz="1400" b="0" i="0" u="none" strike="noStrike" kern="1200" cap="none">
              <a:ln>
                <a:noFill/>
              </a:ln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4528ECE7-FE4D-4C32-A0D9-A3C38DF91985}"/>
              </a:ext>
            </a:extLst>
          </p:cNvPr>
          <p:cNvSpPr txBox="1">
            <a:spLocks noGrp="1"/>
          </p:cNvSpPr>
          <p:nvPr>
            <p:ph type="sldNum" sz="quarter" idx="3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fld id="{99951616-9F47-4CC9-9423-4919635104D1}" type="slidenum">
              <a:t>‹nº›</a:t>
            </a:fld>
            <a:endParaRPr lang="pt-BR" sz="1400" b="0" i="0" u="none" strike="noStrike" kern="1200" cap="none">
              <a:ln>
                <a:noFill/>
              </a:ln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318557372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>
            <a:extLst>
              <a:ext uri="{FF2B5EF4-FFF2-40B4-BE49-F238E27FC236}">
                <a16:creationId xmlns:a16="http://schemas.microsoft.com/office/drawing/2014/main" id="{B1873951-0744-4733-BF2B-C2D620ED640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6000" y="812520"/>
            <a:ext cx="7127279" cy="4008959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Espaço Reservado para Anotações 2">
            <a:extLst>
              <a:ext uri="{FF2B5EF4-FFF2-40B4-BE49-F238E27FC236}">
                <a16:creationId xmlns:a16="http://schemas.microsoft.com/office/drawing/2014/main" id="{33DAE12D-A9AB-43AE-8699-20864DC423EA}"/>
              </a:ext>
            </a:extLst>
          </p:cNvPr>
          <p:cNvSpPr txBox="1">
            <a:spLocks noGrp="1"/>
          </p:cNvSpPr>
          <p:nvPr>
            <p:ph type="body" sz="quarter" idx="3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/>
          <a:p>
            <a:endParaRPr lang="pt-BR"/>
          </a:p>
        </p:txBody>
      </p:sp>
      <p:sp>
        <p:nvSpPr>
          <p:cNvPr id="4" name="Espaço Reservado para Cabeçalho 3">
            <a:extLst>
              <a:ext uri="{FF2B5EF4-FFF2-40B4-BE49-F238E27FC236}">
                <a16:creationId xmlns:a16="http://schemas.microsoft.com/office/drawing/2014/main" id="{7A3C3158-690D-4890-9809-34B0A0D0ADBE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rtl="0" hangingPunct="0">
              <a:buNone/>
              <a:tabLst/>
              <a:defRPr lang="pt-BR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pt-BR"/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0A6A96A0-3F6E-4662-8360-45BFF92E550C}"/>
              </a:ext>
            </a:extLst>
          </p:cNvPr>
          <p:cNvSpPr txBox="1">
            <a:spLocks noGrp="1"/>
          </p:cNvSpPr>
          <p:nvPr>
            <p:ph type="dt" idx="1"/>
          </p:nvPr>
        </p:nvSpPr>
        <p:spPr>
          <a:xfrm>
            <a:off x="4278960" y="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algn="r" rtl="0" hangingPunct="0">
              <a:buNone/>
              <a:tabLst/>
              <a:defRPr lang="pt-BR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26B9E525-929D-440D-B866-45595BA51D92}"/>
              </a:ext>
            </a:extLst>
          </p:cNvPr>
          <p:cNvSpPr txBox="1">
            <a:spLocks noGrp="1"/>
          </p:cNvSpPr>
          <p:nvPr>
            <p:ph type="ftr" sz="quarter" idx="4"/>
          </p:nvPr>
        </p:nvSpPr>
        <p:spPr>
          <a:xfrm>
            <a:off x="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="b" anchorCtr="0">
            <a:noAutofit/>
          </a:bodyPr>
          <a:lstStyle>
            <a:lvl1pPr lvl="0" rtl="0" hangingPunct="0">
              <a:buNone/>
              <a:tabLst/>
              <a:defRPr lang="pt-BR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36665F1-05A4-42BC-BEFD-12A10AD93CF7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="b" anchorCtr="0">
            <a:noAutofit/>
          </a:bodyPr>
          <a:lstStyle>
            <a:lvl1pPr lvl="0" algn="r" rtl="0" hangingPunct="0">
              <a:buNone/>
              <a:tabLst/>
              <a:defRPr lang="pt-BR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C88D6A14-2E72-4FD3-A28C-3005E7D055B7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542500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6000" marR="0" indent="-216000" rtl="0" hangingPunct="0">
      <a:tabLst/>
      <a:defRPr lang="pt-BR" sz="2000" b="0" i="0" u="none" strike="noStrike" kern="1200" cap="none">
        <a:ln>
          <a:noFill/>
        </a:ln>
        <a:highlight>
          <a:scrgbClr r="0" g="0" b="0">
            <a:alpha val="0"/>
          </a:scrgbClr>
        </a:highlight>
        <a:latin typeface="Liberation Sans" pitchFamily="18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31A376C2-F10E-4A3B-9CE4-AEAB2B603B4D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vert="horz" lIns="0" tIns="0" rIns="0" bIns="0" anchor="b" anchorCtr="0">
            <a:noAutofit/>
          </a:bodyPr>
          <a:lstStyle/>
          <a:p>
            <a:pPr lvl="0"/>
            <a:fld id="{33F528E4-D724-4055-B079-FEE18E662AAE}" type="slidenum">
              <a:t>1</a:t>
            </a:fld>
            <a:endParaRPr lang="pt-BR"/>
          </a:p>
        </p:txBody>
      </p:sp>
      <p:sp>
        <p:nvSpPr>
          <p:cNvPr id="2" name="Espaço Reservado para Imagem de Slide 1">
            <a:extLst>
              <a:ext uri="{FF2B5EF4-FFF2-40B4-BE49-F238E27FC236}">
                <a16:creationId xmlns:a16="http://schemas.microsoft.com/office/drawing/2014/main" id="{FBF9E097-7095-454B-8AA6-105CE869514E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217488" y="812800"/>
            <a:ext cx="7124700" cy="4008438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Espaço Reservado para Anotações 2">
            <a:extLst>
              <a:ext uri="{FF2B5EF4-FFF2-40B4-BE49-F238E27FC236}">
                <a16:creationId xmlns:a16="http://schemas.microsoft.com/office/drawing/2014/main" id="{7FA47B87-B079-483B-A7D7-B0F04CBBB08C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 vert="horz"/>
          <a:lstStyle/>
          <a:p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CB5AE0A-F5B4-48DD-980C-3F62FDE32F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60475" y="928688"/>
            <a:ext cx="7559675" cy="197326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204BC85-5ACC-42FF-852F-3F626AF28E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60475" y="2978150"/>
            <a:ext cx="7559675" cy="137001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CDA6808-BCF8-4553-9433-7FA6DF2EA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0D4426C-38E8-4B59-8114-F7EC14F720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EAB6A90-4D19-43FB-A494-7376D9790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4BB9BDE8-632E-48B8-B78E-17CF03407FA2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56164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D89537-3155-4040-96AB-5C4F265D90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7BE2F7D8-8BD1-43D3-8BAF-20CDF9B942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8B4018B-A1BC-453B-81B5-FFBA050C9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788967-BF35-4EBE-B193-C614A90D2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F938B67-5766-4995-8380-C8E859567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DB95BD8-479B-4787-A00C-C472BD1E7FAD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22569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14020C9F-F0A1-4E6D-B090-6CE374BFC9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308850" y="225425"/>
            <a:ext cx="2266950" cy="43894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E446EFAB-8474-42E3-96B4-0AB5C0D61A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03238" y="225425"/>
            <a:ext cx="6653212" cy="43894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58EC675-793C-46C8-A240-919E04BA8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FAEFCAC-350D-40E4-B61A-8D3F823CE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E4E3C59-A383-443C-8B8A-173E83FD2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0F534E1-DF37-402B-B9C7-0F511A4B4E78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60353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E25E33-2A7B-4535-98F0-DA86D5E9CB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E808399-D80F-41A7-B7C3-B4166033F9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8E1AACD-0ED5-4624-933C-FB70E9711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4090CBD-0425-4F86-BD0D-9590B862A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B9A2580-1104-46EA-BB0C-BAA4FD9CE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13CA5063-DC45-4433-888D-B51F236B30EF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85413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913FFB-5DC7-4C47-A058-9AAB71D61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7388" y="1414463"/>
            <a:ext cx="8694737" cy="23574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001B293C-7DEB-4DD2-A36C-C89649D6D5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7388" y="3794125"/>
            <a:ext cx="8694737" cy="124142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B326772-394C-4335-83E9-A48FD13EC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BCDFBD1-AF21-4E7B-BE99-532A61828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ABDCDBA-A16D-4E5C-A15F-9E95F2876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E9E972EA-5184-4B52-8CDC-C13AFE8EC394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40050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48DF362-A3DE-4CBD-907A-EC8AE1A2CD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BE43E88-FD3D-4602-BA0B-C25A155DB1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03238" y="1327150"/>
            <a:ext cx="4459287" cy="328771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E1FFBAF-3FF2-43FE-AAFB-CE97BC3809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114925" y="1327150"/>
            <a:ext cx="4460875" cy="328771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65A9E9AB-BE6A-4FC5-A69A-BB918E5ADC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5D8DC0F9-B356-449D-8392-2D01B457FD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F5969C4-310D-4C05-A4AD-B3E6E778A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763F653-0B35-40A2-A5AB-ABFB1CE18EBD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4263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C7779E-54EB-454D-AEA2-04F909EB94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738" y="301625"/>
            <a:ext cx="8694737" cy="10969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15BD8B4-CDFB-48F0-8E83-3822D43EEC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93738" y="1390650"/>
            <a:ext cx="4265612" cy="681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302EFBF-1281-46FF-960C-7D6E1C807D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93738" y="2071688"/>
            <a:ext cx="4265612" cy="3046412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5353AE66-DDD3-4F70-931B-E06CDEAE82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103813" y="1390650"/>
            <a:ext cx="4284662" cy="681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79C59CEA-89F4-4DCB-BFDA-3C59BE08B2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103813" y="2071688"/>
            <a:ext cx="4284662" cy="3046412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EC5596F9-078B-44EB-B421-6728E27F0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70FBB280-8398-4426-8788-3F65EA823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85B3E551-BA1C-4FEF-9F52-FFA304C72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77C8417-A77F-458D-BA83-290D8423FD8B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56067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03C93B-5987-40C3-ABA0-F3CD1D6479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6F646B9A-637D-4BC3-84A8-F556CA28A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96D164E5-B6A1-4324-8C00-5A4D55623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CEA8F9F2-7B48-47ED-8DD0-356D5BB72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0810F3A4-5209-45DF-A6A1-1B16176EABD7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61048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89F80E18-2271-4478-9BD4-E2DB270AB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AA272E09-4657-45B0-9F0E-177992804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89BA7D18-BA85-48A1-968F-C3AB2FF6C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2036FF1B-91E8-4149-845C-06B48E802C2F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13991785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A218BD-ED3D-4543-9435-FA71455721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738" y="377825"/>
            <a:ext cx="3251200" cy="132397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14B13D9-56BC-4CFB-BA90-6D0267F82B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86250" y="815975"/>
            <a:ext cx="5102225" cy="40306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1197304A-1756-4736-88F2-F497378D06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93738" y="1701800"/>
            <a:ext cx="3251200" cy="31511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7959789-92D2-4DE0-A398-3F98E5DB7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628F40FA-0296-4854-A054-42AD16E3E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BC89E37D-49F7-4FE2-870A-7D3E850C0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69380C3-B289-4D12-B46E-F2CF7A1F3A6A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28346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FB0E97F-B3EC-4ADD-B59B-627D70D60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738" y="377825"/>
            <a:ext cx="3251200" cy="1323975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09CC7A4C-75C7-4F20-B7B0-86CCFEFFB4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86250" y="815975"/>
            <a:ext cx="5102225" cy="40306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21891137-B580-4B6B-AEF4-65398F58AC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93738" y="1701800"/>
            <a:ext cx="3251200" cy="31511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F78E596-A72F-4042-AFF7-89413A057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8110026-6E67-4174-8485-CBEF4C732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6C543AC-FAE7-4575-BB03-AC89A3D9D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BFD3195A-B8C2-4215-8DA9-9C587C0EBBC2}" type="slidenum"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61750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71A4EBC8-9C27-4BC2-B14B-F14BB694036B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503999" y="226080"/>
            <a:ext cx="9071640" cy="94644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ctr"/>
          <a:lstStyle/>
          <a:p>
            <a:endParaRPr lang="pt-BR"/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26FAFAB-100A-40F5-8B20-6E7136C06E48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503999" y="1326600"/>
            <a:ext cx="9071640" cy="3288239"/>
          </a:xfrm>
          <a:prstGeom prst="rect">
            <a:avLst/>
          </a:prstGeom>
          <a:noFill/>
          <a:ln>
            <a:noFill/>
          </a:ln>
        </p:spPr>
        <p:txBody>
          <a:bodyPr lIns="0" tIns="0" rIns="0" bIns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AD1E104-CCA1-4555-8142-7A219BCC396C}"/>
              </a:ext>
            </a:extLst>
          </p:cNvPr>
          <p:cNvSpPr txBox="1">
            <a:spLocks noGrp="1"/>
          </p:cNvSpPr>
          <p:nvPr>
            <p:ph type="dt" sz="half" idx="2"/>
          </p:nvPr>
        </p:nvSpPr>
        <p:spPr>
          <a:xfrm>
            <a:off x="503999" y="5165280"/>
            <a:ext cx="2348280" cy="39060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rtl="0" hangingPunct="0">
              <a:buNone/>
              <a:tabLst/>
              <a:defRPr lang="pt-BR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8DD6633-47B1-45D7-96EA-7D4D88FFD124}"/>
              </a:ext>
            </a:extLst>
          </p:cNvPr>
          <p:cNvSpPr txBox="1">
            <a:spLocks noGrp="1"/>
          </p:cNvSpPr>
          <p:nvPr>
            <p:ph type="ftr" sz="quarter" idx="3"/>
          </p:nvPr>
        </p:nvSpPr>
        <p:spPr>
          <a:xfrm>
            <a:off x="3447360" y="5165280"/>
            <a:ext cx="3195000" cy="39060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algn="ctr" rtl="0" hangingPunct="0">
              <a:buNone/>
              <a:tabLst/>
              <a:defRPr lang="pt-BR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6AC159B-903A-4AF8-AF32-DEF31F2E184D}"/>
              </a:ext>
            </a:extLst>
          </p:cNvPr>
          <p:cNvSpPr txBox="1">
            <a:spLocks noGrp="1"/>
          </p:cNvSpPr>
          <p:nvPr>
            <p:ph type="sldNum" sz="quarter" idx="4"/>
          </p:nvPr>
        </p:nvSpPr>
        <p:spPr>
          <a:xfrm>
            <a:off x="7227360" y="5165280"/>
            <a:ext cx="2348280" cy="390600"/>
          </a:xfrm>
          <a:prstGeom prst="rect">
            <a:avLst/>
          </a:prstGeom>
          <a:noFill/>
          <a:ln>
            <a:noFill/>
          </a:ln>
        </p:spPr>
        <p:txBody>
          <a:bodyPr vert="horz" lIns="0" tIns="0" rIns="0" bIns="0" anchorCtr="0">
            <a:noAutofit/>
          </a:bodyPr>
          <a:lstStyle>
            <a:lvl1pPr lvl="0" algn="r" rtl="0" hangingPunct="0">
              <a:buNone/>
              <a:tabLst/>
              <a:defRPr lang="pt-BR" sz="1400" kern="1200">
                <a:latin typeface="Liberation Serif" pitchFamily="18"/>
                <a:ea typeface="DejaVu Sans" pitchFamily="2"/>
                <a:cs typeface="DejaVu Sans" pitchFamily="2"/>
              </a:defRPr>
            </a:lvl1pPr>
          </a:lstStyle>
          <a:p>
            <a:pPr lvl="0"/>
            <a:fld id="{A2F840D2-6A49-415B-8622-92E70C349A2A}" type="slidenum"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hangingPunct="0">
        <a:tabLst/>
        <a:defRPr lang="pt-BR" sz="44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</a:defRPr>
      </a:lvl1pPr>
    </p:titleStyle>
    <p:bodyStyle>
      <a:lvl1pPr rtl="0" hangingPunct="0">
        <a:spcBef>
          <a:spcPts val="1417"/>
        </a:spcBef>
        <a:spcAft>
          <a:spcPts val="0"/>
        </a:spcAft>
        <a:tabLst/>
        <a:defRPr lang="pt-BR" sz="3200" b="0" i="0" u="none" strike="noStrike" kern="1200" cap="none">
          <a:ln>
            <a:noFill/>
          </a:ln>
          <a:highlight>
            <a:scrgbClr r="0" g="0" b="0">
              <a:alpha val="0"/>
            </a:scrgbClr>
          </a:highlight>
          <a:latin typeface="Liberation Sans" pitchFamily="18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pag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rma Livre: Forma 1">
            <a:extLst>
              <a:ext uri="{FF2B5EF4-FFF2-40B4-BE49-F238E27FC236}">
                <a16:creationId xmlns:a16="http://schemas.microsoft.com/office/drawing/2014/main" id="{8600495F-54AB-45B9-BECF-15B8BA4C8FAA}"/>
              </a:ext>
            </a:extLst>
          </p:cNvPr>
          <p:cNvSpPr/>
          <p:nvPr/>
        </p:nvSpPr>
        <p:spPr>
          <a:xfrm>
            <a:off x="900188" y="1381273"/>
            <a:ext cx="1368000" cy="864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solidFill>
            <a:srgbClr val="FFFFFF"/>
          </a:solidFill>
          <a:ln w="36000">
            <a:solidFill>
              <a:srgbClr val="000000"/>
            </a:solidFill>
            <a:prstDash val="solid"/>
          </a:ln>
        </p:spPr>
        <p:txBody>
          <a:bodyPr vert="horz" wrap="none" lIns="108000" tIns="63000" rIns="108000" bIns="63000" anchor="ctr" anchorCtr="0" compatLnSpc="0">
            <a:no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Sequencing</a:t>
            </a:r>
          </a:p>
        </p:txBody>
      </p:sp>
      <p:sp>
        <p:nvSpPr>
          <p:cNvPr id="3" name="Forma Livre: Forma 2">
            <a:extLst>
              <a:ext uri="{FF2B5EF4-FFF2-40B4-BE49-F238E27FC236}">
                <a16:creationId xmlns:a16="http://schemas.microsoft.com/office/drawing/2014/main" id="{728D30A9-A327-4EAD-9BB7-D2E92A44B4AA}"/>
              </a:ext>
            </a:extLst>
          </p:cNvPr>
          <p:cNvSpPr/>
          <p:nvPr/>
        </p:nvSpPr>
        <p:spPr>
          <a:xfrm>
            <a:off x="1620188" y="2893273"/>
            <a:ext cx="1944000" cy="1800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solidFill>
            <a:srgbClr val="FFFFFF"/>
          </a:solidFill>
          <a:ln w="36000">
            <a:solidFill>
              <a:srgbClr val="000000"/>
            </a:solidFill>
            <a:prstDash val="solid"/>
          </a:ln>
        </p:spPr>
        <p:txBody>
          <a:bodyPr vert="horz" wrap="none" lIns="108000" tIns="63000" rIns="108000" bIns="63000" anchor="ctr" anchorCtr="0" compatLnSpc="0">
            <a:no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Adaptor removal,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Quality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Filtering and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size filtering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(Fastx-toolkit)</a:t>
            </a:r>
          </a:p>
        </p:txBody>
      </p:sp>
      <p:cxnSp>
        <p:nvCxnSpPr>
          <p:cNvPr id="4" name="Conector: Angulado 3">
            <a:extLst>
              <a:ext uri="{FF2B5EF4-FFF2-40B4-BE49-F238E27FC236}">
                <a16:creationId xmlns:a16="http://schemas.microsoft.com/office/drawing/2014/main" id="{DAF46B95-15B3-4F8F-856D-ACF1911CDDE2}"/>
              </a:ext>
            </a:extLst>
          </p:cNvPr>
          <p:cNvCxnSpPr>
            <a:cxnSpLocks/>
            <a:stCxn id="2" idx="1"/>
            <a:endCxn id="3" idx="0"/>
          </p:cNvCxnSpPr>
          <p:nvPr/>
        </p:nvCxnSpPr>
        <p:spPr>
          <a:xfrm>
            <a:off x="2268188" y="1813273"/>
            <a:ext cx="324000" cy="1080000"/>
          </a:xfrm>
          <a:prstGeom prst="bentConnector2">
            <a:avLst/>
          </a:prstGeom>
          <a:noFill/>
          <a:ln w="36000">
            <a:solidFill>
              <a:srgbClr val="000000"/>
            </a:solidFill>
            <a:prstDash val="solid"/>
            <a:tailEnd type="arrow"/>
          </a:ln>
        </p:spPr>
      </p:cxnSp>
      <p:sp>
        <p:nvSpPr>
          <p:cNvPr id="5" name="Forma Livre: Forma 4">
            <a:extLst>
              <a:ext uri="{FF2B5EF4-FFF2-40B4-BE49-F238E27FC236}">
                <a16:creationId xmlns:a16="http://schemas.microsoft.com/office/drawing/2014/main" id="{F1319C52-2296-4920-87BC-19BAD696C823}"/>
              </a:ext>
            </a:extLst>
          </p:cNvPr>
          <p:cNvSpPr/>
          <p:nvPr/>
        </p:nvSpPr>
        <p:spPr>
          <a:xfrm>
            <a:off x="4212188" y="2389273"/>
            <a:ext cx="2232000" cy="864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solidFill>
            <a:srgbClr val="FFFFFF"/>
          </a:solidFill>
          <a:ln w="36000">
            <a:solidFill>
              <a:srgbClr val="000000"/>
            </a:solidFill>
            <a:prstDash val="solid"/>
          </a:ln>
        </p:spPr>
        <p:txBody>
          <a:bodyPr vert="horz" wrap="none" lIns="108000" tIns="63000" rIns="108000" bIns="63000" anchor="ctr" anchorCtr="0" compatLnSpc="0">
            <a:no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Alignment against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Precursor reference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(Hisat2)</a:t>
            </a:r>
          </a:p>
        </p:txBody>
      </p:sp>
      <p:cxnSp>
        <p:nvCxnSpPr>
          <p:cNvPr id="6" name="Conector: Angulado 5">
            <a:extLst>
              <a:ext uri="{FF2B5EF4-FFF2-40B4-BE49-F238E27FC236}">
                <a16:creationId xmlns:a16="http://schemas.microsoft.com/office/drawing/2014/main" id="{6F8E6383-0633-4690-9BFB-C180D86094A6}"/>
              </a:ext>
            </a:extLst>
          </p:cNvPr>
          <p:cNvCxnSpPr>
            <a:stCxn id="3" idx="1"/>
            <a:endCxn id="5" idx="3"/>
          </p:cNvCxnSpPr>
          <p:nvPr/>
        </p:nvCxnSpPr>
        <p:spPr>
          <a:xfrm flipV="1">
            <a:off x="3564188" y="2821273"/>
            <a:ext cx="648000" cy="972000"/>
          </a:xfrm>
          <a:prstGeom prst="bentConnector3">
            <a:avLst>
              <a:gd name="adj1" fmla="val 50000"/>
            </a:avLst>
          </a:prstGeom>
          <a:noFill/>
          <a:ln w="36000">
            <a:solidFill>
              <a:srgbClr val="000000"/>
            </a:solidFill>
            <a:prstDash val="solid"/>
            <a:tailEnd type="arrow"/>
          </a:ln>
        </p:spPr>
      </p:cxnSp>
      <p:sp>
        <p:nvSpPr>
          <p:cNvPr id="7" name="Forma Livre: Forma 6">
            <a:extLst>
              <a:ext uri="{FF2B5EF4-FFF2-40B4-BE49-F238E27FC236}">
                <a16:creationId xmlns:a16="http://schemas.microsoft.com/office/drawing/2014/main" id="{FDF6CF10-D48F-42D2-BF7B-6D2ACEA551D4}"/>
              </a:ext>
            </a:extLst>
          </p:cNvPr>
          <p:cNvSpPr/>
          <p:nvPr/>
        </p:nvSpPr>
        <p:spPr>
          <a:xfrm>
            <a:off x="3204188" y="1093273"/>
            <a:ext cx="2592000" cy="864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solidFill>
            <a:srgbClr val="FFFFFF"/>
          </a:solidFill>
          <a:ln w="36000">
            <a:solidFill>
              <a:srgbClr val="000000"/>
            </a:solidFill>
            <a:prstDash val="solid"/>
          </a:ln>
        </p:spPr>
        <p:txBody>
          <a:bodyPr vert="horz" wrap="none" lIns="108000" tIns="63000" rIns="108000" bIns="63000" anchor="ctr" anchorCtr="0" compatLnSpc="0">
            <a:no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Mature and Precursor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Alignment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(miRBase and GMAP)</a:t>
            </a:r>
          </a:p>
        </p:txBody>
      </p:sp>
      <p:sp>
        <p:nvSpPr>
          <p:cNvPr id="8" name="Forma Livre: Forma 7">
            <a:extLst>
              <a:ext uri="{FF2B5EF4-FFF2-40B4-BE49-F238E27FC236}">
                <a16:creationId xmlns:a16="http://schemas.microsoft.com/office/drawing/2014/main" id="{616046D2-897B-475B-BC48-6A7D1E4EE1B1}"/>
              </a:ext>
            </a:extLst>
          </p:cNvPr>
          <p:cNvSpPr/>
          <p:nvPr/>
        </p:nvSpPr>
        <p:spPr>
          <a:xfrm>
            <a:off x="7092188" y="2029273"/>
            <a:ext cx="2232000" cy="864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solidFill>
            <a:srgbClr val="FFFFFF"/>
          </a:solidFill>
          <a:ln w="36000">
            <a:solidFill>
              <a:srgbClr val="000000"/>
            </a:solidFill>
            <a:prstDash val="solid"/>
          </a:ln>
        </p:spPr>
        <p:txBody>
          <a:bodyPr vert="horz" wrap="none" lIns="108000" tIns="63000" rIns="108000" bIns="63000" anchor="ctr" anchorCtr="0" compatLnSpc="0">
            <a:no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Read-count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(featureCounts)</a:t>
            </a:r>
          </a:p>
        </p:txBody>
      </p:sp>
      <p:cxnSp>
        <p:nvCxnSpPr>
          <p:cNvPr id="9" name="Conector: Angulado 8">
            <a:extLst>
              <a:ext uri="{FF2B5EF4-FFF2-40B4-BE49-F238E27FC236}">
                <a16:creationId xmlns:a16="http://schemas.microsoft.com/office/drawing/2014/main" id="{2909FA2A-C780-4560-8D5E-1B7D5F5A4070}"/>
              </a:ext>
            </a:extLst>
          </p:cNvPr>
          <p:cNvCxnSpPr>
            <a:stCxn id="5" idx="1"/>
            <a:endCxn id="8" idx="3"/>
          </p:cNvCxnSpPr>
          <p:nvPr/>
        </p:nvCxnSpPr>
        <p:spPr>
          <a:xfrm flipV="1">
            <a:off x="6444188" y="2461273"/>
            <a:ext cx="648000" cy="360000"/>
          </a:xfrm>
          <a:prstGeom prst="bentConnector3">
            <a:avLst>
              <a:gd name="adj1" fmla="val 50000"/>
            </a:avLst>
          </a:prstGeom>
          <a:noFill/>
          <a:ln w="36000">
            <a:solidFill>
              <a:srgbClr val="000000"/>
            </a:solidFill>
            <a:prstDash val="solid"/>
            <a:tailEnd type="arrow"/>
          </a:ln>
        </p:spPr>
      </p:cxnSp>
      <p:cxnSp>
        <p:nvCxnSpPr>
          <p:cNvPr id="10" name="Conector: Angulado 9">
            <a:extLst>
              <a:ext uri="{FF2B5EF4-FFF2-40B4-BE49-F238E27FC236}">
                <a16:creationId xmlns:a16="http://schemas.microsoft.com/office/drawing/2014/main" id="{54AC3C17-A6A1-4539-811A-5792C5B9A1E2}"/>
              </a:ext>
            </a:extLst>
          </p:cNvPr>
          <p:cNvCxnSpPr>
            <a:stCxn id="7" idx="1"/>
            <a:endCxn id="11" idx="3"/>
          </p:cNvCxnSpPr>
          <p:nvPr/>
        </p:nvCxnSpPr>
        <p:spPr>
          <a:xfrm flipV="1">
            <a:off x="5796188" y="949273"/>
            <a:ext cx="1152000" cy="576000"/>
          </a:xfrm>
          <a:prstGeom prst="bentConnector3">
            <a:avLst>
              <a:gd name="adj1" fmla="val 50000"/>
            </a:avLst>
          </a:prstGeom>
          <a:noFill/>
          <a:ln w="36000">
            <a:solidFill>
              <a:srgbClr val="000000"/>
            </a:solidFill>
            <a:prstDash val="solid"/>
            <a:tailEnd type="arrow"/>
          </a:ln>
        </p:spPr>
      </p:cxnSp>
      <p:sp>
        <p:nvSpPr>
          <p:cNvPr id="11" name="Forma Livre: Forma 10">
            <a:extLst>
              <a:ext uri="{FF2B5EF4-FFF2-40B4-BE49-F238E27FC236}">
                <a16:creationId xmlns:a16="http://schemas.microsoft.com/office/drawing/2014/main" id="{3A759AED-405D-4116-ABBE-1E9E60781689}"/>
              </a:ext>
            </a:extLst>
          </p:cNvPr>
          <p:cNvSpPr/>
          <p:nvPr/>
        </p:nvSpPr>
        <p:spPr>
          <a:xfrm>
            <a:off x="6948188" y="517273"/>
            <a:ext cx="2232000" cy="864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solidFill>
            <a:srgbClr val="FFFFFF"/>
          </a:solidFill>
          <a:ln w="36000">
            <a:solidFill>
              <a:srgbClr val="000000"/>
            </a:solidFill>
            <a:prstDash val="solid"/>
          </a:ln>
        </p:spPr>
        <p:txBody>
          <a:bodyPr vert="horz" wrap="none" lIns="108000" tIns="63000" rIns="108000" bIns="63000" anchor="ctr" anchorCtr="0" compatLnSpc="0">
            <a:no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GFF annotation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(mature sequences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over precursor)</a:t>
            </a:r>
          </a:p>
        </p:txBody>
      </p:sp>
      <p:cxnSp>
        <p:nvCxnSpPr>
          <p:cNvPr id="12" name="Conector: Angulado 11">
            <a:extLst>
              <a:ext uri="{FF2B5EF4-FFF2-40B4-BE49-F238E27FC236}">
                <a16:creationId xmlns:a16="http://schemas.microsoft.com/office/drawing/2014/main" id="{8E41C481-3AF4-47DF-9981-008E5BDD5952}"/>
              </a:ext>
            </a:extLst>
          </p:cNvPr>
          <p:cNvCxnSpPr>
            <a:cxnSpLocks/>
            <a:stCxn id="11" idx="2"/>
            <a:endCxn id="8" idx="0"/>
          </p:cNvCxnSpPr>
          <p:nvPr/>
        </p:nvCxnSpPr>
        <p:spPr>
          <a:xfrm rot="16200000" flipH="1">
            <a:off x="7812188" y="1633273"/>
            <a:ext cx="648000" cy="144000"/>
          </a:xfrm>
          <a:prstGeom prst="bentConnector3">
            <a:avLst/>
          </a:prstGeom>
          <a:noFill/>
          <a:ln w="36000">
            <a:solidFill>
              <a:srgbClr val="000000"/>
            </a:solidFill>
            <a:prstDash val="solid"/>
            <a:tailEnd type="arrow"/>
          </a:ln>
        </p:spPr>
      </p:cxnSp>
      <p:sp>
        <p:nvSpPr>
          <p:cNvPr id="13" name="Forma Livre: Forma 12">
            <a:extLst>
              <a:ext uri="{FF2B5EF4-FFF2-40B4-BE49-F238E27FC236}">
                <a16:creationId xmlns:a16="http://schemas.microsoft.com/office/drawing/2014/main" id="{CC4B50DF-846F-41A6-B992-CF77DF1151B0}"/>
              </a:ext>
            </a:extLst>
          </p:cNvPr>
          <p:cNvSpPr/>
          <p:nvPr/>
        </p:nvSpPr>
        <p:spPr>
          <a:xfrm>
            <a:off x="6156188" y="3541273"/>
            <a:ext cx="2412000" cy="864000"/>
          </a:xfrm>
          <a:custGeom>
            <a:avLst/>
            <a:gdLst>
              <a:gd name="f0" fmla="val 0"/>
              <a:gd name="f1" fmla="val 21600"/>
            </a:gdLst>
            <a:ahLst/>
            <a:cxnLst>
              <a:cxn ang="3cd4">
                <a:pos x="hc" y="t"/>
              </a:cxn>
              <a:cxn ang="0">
                <a:pos x="r" y="vc"/>
              </a:cxn>
              <a:cxn ang="cd4">
                <a:pos x="hc" y="b"/>
              </a:cxn>
              <a:cxn ang="cd2">
                <a:pos x="l" y="vc"/>
              </a:cxn>
            </a:cxnLst>
            <a:rect l="l" t="t" r="r" b="b"/>
            <a:pathLst>
              <a:path w="21600" h="21600">
                <a:moveTo>
                  <a:pt x="f0" y="f0"/>
                </a:moveTo>
                <a:lnTo>
                  <a:pt x="f1" y="f0"/>
                </a:lnTo>
                <a:lnTo>
                  <a:pt x="f1" y="f1"/>
                </a:lnTo>
                <a:lnTo>
                  <a:pt x="f0" y="f1"/>
                </a:lnTo>
                <a:lnTo>
                  <a:pt x="f0" y="f0"/>
                </a:lnTo>
                <a:close/>
              </a:path>
            </a:pathLst>
          </a:custGeom>
          <a:solidFill>
            <a:srgbClr val="FFFFFF"/>
          </a:solidFill>
          <a:ln w="36000">
            <a:solidFill>
              <a:srgbClr val="000000"/>
            </a:solidFill>
            <a:prstDash val="solid"/>
          </a:ln>
        </p:spPr>
        <p:txBody>
          <a:bodyPr vert="horz" wrap="none" lIns="108000" tIns="63000" rIns="108000" bIns="63000" anchor="ctr" anchorCtr="0" compatLnSpc="0">
            <a:noAutofit/>
          </a:bodyPr>
          <a:lstStyle/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Differential Expression</a:t>
            </a:r>
          </a:p>
          <a:p>
            <a:pPr marL="0" marR="0" lvl="0" indent="0" algn="ct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</a:pPr>
            <a:r>
              <a:rPr lang="pt-BR" sz="1800" b="0" i="0" u="none" strike="noStrike" kern="1200" cap="none">
                <a:ln>
                  <a:noFill/>
                </a:ln>
                <a:latin typeface="Liberation Sans" pitchFamily="18"/>
                <a:ea typeface="Noto Sans CJK SC" pitchFamily="2"/>
                <a:cs typeface="Lohit Devanagari" pitchFamily="2"/>
              </a:rPr>
              <a:t>(DESeq2)</a:t>
            </a:r>
          </a:p>
        </p:txBody>
      </p:sp>
      <p:cxnSp>
        <p:nvCxnSpPr>
          <p:cNvPr id="14" name="Conector: Angulado 13">
            <a:extLst>
              <a:ext uri="{FF2B5EF4-FFF2-40B4-BE49-F238E27FC236}">
                <a16:creationId xmlns:a16="http://schemas.microsoft.com/office/drawing/2014/main" id="{6F0AC99C-12FE-4DCA-9B10-90B5AD815155}"/>
              </a:ext>
            </a:extLst>
          </p:cNvPr>
          <p:cNvCxnSpPr>
            <a:cxnSpLocks/>
            <a:stCxn id="8" idx="2"/>
            <a:endCxn id="13" idx="0"/>
          </p:cNvCxnSpPr>
          <p:nvPr/>
        </p:nvCxnSpPr>
        <p:spPr>
          <a:xfrm rot="5400000">
            <a:off x="7461188" y="2794273"/>
            <a:ext cx="648000" cy="846000"/>
          </a:xfrm>
          <a:prstGeom prst="bentConnector3">
            <a:avLst/>
          </a:prstGeom>
          <a:noFill/>
          <a:ln w="36000">
            <a:solidFill>
              <a:srgbClr val="000000"/>
            </a:solidFill>
            <a:prstDash val="solid"/>
            <a:tailEnd type="arrow"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Padrão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6</Words>
  <Application>Microsoft Office PowerPoint</Application>
  <PresentationFormat>Widescreen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Liberation Sans</vt:lpstr>
      <vt:lpstr>Liberation Serif</vt:lpstr>
      <vt:lpstr>Padrão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cp:lastModifiedBy>Bruno Fantinatti</cp:lastModifiedBy>
  <cp:revision>4</cp:revision>
  <dcterms:created xsi:type="dcterms:W3CDTF">2021-01-15T18:19:48Z</dcterms:created>
  <dcterms:modified xsi:type="dcterms:W3CDTF">2021-01-15T21:38:50Z</dcterms:modified>
</cp:coreProperties>
</file>